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1" r:id="rId3"/>
    <p:sldId id="272" r:id="rId4"/>
    <p:sldId id="269" r:id="rId5"/>
    <p:sldId id="276" r:id="rId6"/>
    <p:sldId id="275" r:id="rId7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56"/>
  </p:normalViewPr>
  <p:slideViewPr>
    <p:cSldViewPr>
      <p:cViewPr varScale="1">
        <p:scale>
          <a:sx n="40" d="100"/>
          <a:sy n="40" d="100"/>
        </p:scale>
        <p:origin x="2022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129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344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167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747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329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80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353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90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175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92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953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31954-71F4-4F06-8D1D-0387692B59A5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58100-A586-4D6B-90AC-C7F3C778F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678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88B7523-0169-43EA-9F7B-0A2A3C3EFA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9136" y="5257800"/>
            <a:ext cx="4145280" cy="15925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F9D17A8-5BD6-4BA0-AACA-5603915AB3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0600" y="685800"/>
            <a:ext cx="5102352" cy="4724400"/>
          </a:xfrm>
          <a:prstGeom prst="rect">
            <a:avLst/>
          </a:prstGeom>
        </p:spPr>
      </p:pic>
      <p:sp>
        <p:nvSpPr>
          <p:cNvPr id="8" name="矩形 12">
            <a:extLst>
              <a:ext uri="{FF2B5EF4-FFF2-40B4-BE49-F238E27FC236}">
                <a16:creationId xmlns:a16="http://schemas.microsoft.com/office/drawing/2014/main" id="{EEFF52CE-191B-4322-A5C7-1C8D0E47CCBB}"/>
              </a:ext>
            </a:extLst>
          </p:cNvPr>
          <p:cNvSpPr/>
          <p:nvPr/>
        </p:nvSpPr>
        <p:spPr>
          <a:xfrm>
            <a:off x="715910" y="6836137"/>
            <a:ext cx="5377042" cy="11233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|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Amino acid sequence alignments of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AtPLD</a:t>
            </a:r>
            <a:r>
              <a:rPr lang="en-US" sz="1100" dirty="0" err="1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, GmPLD</a:t>
            </a:r>
            <a:r>
              <a:rPr lang="en-US" sz="1100" dirty="0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1 and GmPLD</a:t>
            </a:r>
            <a:r>
              <a:rPr lang="en-US" sz="1100" dirty="0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2 (A). The multiple sequence alignments were constructed by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Jalview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. (B) RT-qPCR analysis of relative expression level of GmPLD</a:t>
            </a:r>
            <a:r>
              <a:rPr lang="en-US" sz="1100" dirty="0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1 and GmPLD</a:t>
            </a:r>
            <a:r>
              <a:rPr lang="en-US" sz="1100" dirty="0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2 in the leaves of </a:t>
            </a:r>
            <a:r>
              <a:rPr lang="en-US" sz="1100" i="1" dirty="0" err="1">
                <a:latin typeface="Times New Roman" pitchFamily="18" charset="0"/>
                <a:cs typeface="Times New Roman" pitchFamily="18" charset="0"/>
              </a:rPr>
              <a:t>AtPLD</a:t>
            </a:r>
            <a:r>
              <a:rPr lang="en-US" sz="1100" i="1" dirty="0" err="1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sz="1100" dirty="0">
                <a:latin typeface="Symbol" panose="05050102010706020507" pitchFamily="18" charset="2"/>
                <a:cs typeface="Times New Roman" pitchFamily="18" charset="0"/>
              </a:rPr>
              <a:t>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OE1 under nitrogen-sufficient and -deficient conditions. Two-week-old soybeans grown on nitrogen rich liquid medium were transferred to nitrogen rich (6 mM N) or free (0 mM) liquid medium for 7 days. The values are means ± SD (n=3). </a:t>
            </a:r>
            <a:endParaRPr lang="en-US" sz="11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697E5C-BC9B-41F2-A4FE-AB71C0F0F692}"/>
              </a:ext>
            </a:extLst>
          </p:cNvPr>
          <p:cNvSpPr txBox="1"/>
          <p:nvPr/>
        </p:nvSpPr>
        <p:spPr>
          <a:xfrm>
            <a:off x="738699" y="408801"/>
            <a:ext cx="360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3BE62F-CF8D-49DE-8DB3-1D25D0030E8C}"/>
              </a:ext>
            </a:extLst>
          </p:cNvPr>
          <p:cNvSpPr txBox="1"/>
          <p:nvPr/>
        </p:nvSpPr>
        <p:spPr>
          <a:xfrm>
            <a:off x="715910" y="5431564"/>
            <a:ext cx="415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71653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矩形 12"/>
          <p:cNvSpPr/>
          <p:nvPr/>
        </p:nvSpPr>
        <p:spPr>
          <a:xfrm>
            <a:off x="1371600" y="5561897"/>
            <a:ext cx="3810000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Figure 2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|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Relative root length, leaf area and chlorophyll content in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WT and </a:t>
            </a:r>
            <a:r>
              <a:rPr lang="en-US" altLang="zh-CN" sz="1100" i="1" dirty="0" err="1">
                <a:latin typeface="Times New Roman" pitchFamily="18" charset="0"/>
                <a:cs typeface="Times New Roman" pitchFamily="18" charset="0"/>
              </a:rPr>
              <a:t>AtPLD</a:t>
            </a:r>
            <a:r>
              <a:rPr lang="en-US" altLang="zh-CN" sz="1100" i="1" dirty="0" err="1">
                <a:latin typeface="Symbol" panose="05050102010706020507" pitchFamily="18" charset="2"/>
                <a:cs typeface="Times New Roman" pitchFamily="18" charset="0"/>
              </a:rPr>
              <a:t>e</a:t>
            </a:r>
            <a:r>
              <a:rPr lang="en-US" altLang="zh-CN" sz="11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OE</a:t>
            </a:r>
            <a:r>
              <a:rPr lang="en-US" altLang="zh-CN" sz="11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soybean plants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Two-week-old soybeans grown on nitrogen rich liquid medium were transferred to nitrogen rich and free medium for 7 days.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relative contents were calculated by comparing the values for nitrogen-free condition with nitrogen-sufficient condition.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The values are means ± SD of five biological replicates. * denotes statistical significance at P &lt; 0.05 compared with WT as determined by one-way ANOVA (Duncan's multiple range test).</a:t>
            </a:r>
            <a:endParaRPr lang="en-US" sz="11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0DED04-1652-4BBE-9CD1-3447574537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2600" y="1447800"/>
            <a:ext cx="2593599" cy="4096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2192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143000" y="5334000"/>
            <a:ext cx="4419600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|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ctivity of nitrate reductase, nitrite reductase and glutamine synthetase in the leaves of WT, and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PLD</a:t>
            </a:r>
            <a:r>
              <a:rPr lang="en-US" sz="1100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 soybean.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Two-week-old soybean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n on nitrogen rich liquid medium were transferred to nitrogen rich and free medium for 7 days. </a:t>
            </a:r>
            <a:r>
              <a:rPr lang="en-US" altLang="zh-CN" sz="1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relative contents were calculated by comparing the values for nitrogen-free condition with nitrogen-sufficient condition. </a:t>
            </a:r>
            <a:r>
              <a:rPr lang="en-US" altLang="zh-CN" sz="1100" dirty="0">
                <a:latin typeface="Times New Roman" pitchFamily="18" charset="0"/>
                <a:cs typeface="Times New Roman" pitchFamily="18" charset="0"/>
              </a:rPr>
              <a:t>The values are means ± SD of five biological replicates. * denotes statistical significance at P &lt; 0.05 and ** denotes statistical significance at P &lt; 0.001 compared with WT as determined by one-way ANOVA (Duncan's multiple range test)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A589F43-254E-4B6E-B8DF-4EDA99EC7A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3298" y="990600"/>
            <a:ext cx="2699004" cy="4116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86814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F3D5AE1-43F9-442D-92AD-C2DF7D85721E}"/>
              </a:ext>
            </a:extLst>
          </p:cNvPr>
          <p:cNvSpPr txBox="1"/>
          <p:nvPr/>
        </p:nvSpPr>
        <p:spPr>
          <a:xfrm>
            <a:off x="838200" y="5562600"/>
            <a:ext cx="4389120" cy="11233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|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CN" sz="11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Lipid contents in nodules collected from WT and </a:t>
            </a:r>
            <a:r>
              <a:rPr kumimoji="0" lang="en-US" altLang="zh-CN" sz="110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AtPLD</a:t>
            </a:r>
            <a:r>
              <a:rPr kumimoji="0" lang="en-US" altLang="zh-CN" sz="110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anose="05050102010706020507" pitchFamily="18" charset="2"/>
                <a:ea typeface="SimSun" panose="02010600030101010101" pitchFamily="2" charset="-122"/>
                <a:cs typeface="+mn-cs"/>
              </a:rPr>
              <a:t>e</a:t>
            </a:r>
            <a:r>
              <a:rPr kumimoji="0" lang="en-US" altLang="zh-CN" sz="11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 OE soybean.</a:t>
            </a: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Three-week-old soybeans grown on vermiculite supplied with 0.6 mM N were infected with 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B. </a:t>
            </a:r>
            <a:r>
              <a:rPr kumimoji="0" lang="en-US" altLang="zh-CN" sz="1100" b="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diazoefficiens</a:t>
            </a:r>
            <a:r>
              <a:rPr kumimoji="0" lang="en-US" altLang="zh-CN" sz="11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USDA110 and maintained for 28 days. The nodules collected from WT and </a:t>
            </a:r>
            <a:r>
              <a:rPr kumimoji="0" lang="en-US" altLang="zh-CN" sz="1100" b="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AtPLD</a:t>
            </a:r>
            <a:r>
              <a:rPr kumimoji="0" lang="en-US" altLang="zh-CN" sz="1100" b="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anose="05050102010706020507" pitchFamily="18" charset="2"/>
                <a:ea typeface="SimSun" panose="02010600030101010101" pitchFamily="2" charset="-122"/>
                <a:cs typeface="+mn-cs"/>
              </a:rPr>
              <a:t>e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SimSun" panose="02010600030101010101" pitchFamily="2" charset="-122"/>
                <a:cs typeface="+mn-cs"/>
              </a:rPr>
              <a:t> OE soybean were used for lipid analysis. </a:t>
            </a: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values are means ± SD of four biological replicates.</a:t>
            </a:r>
            <a:endParaRPr lang="zh-CN" altLang="en-US" sz="11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95EA7E4-0C24-4E52-98CC-CD09E3956A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3119628"/>
            <a:ext cx="4658868" cy="2442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65681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65F4FA6-D7BC-452C-8CC4-0F856AB47D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1676400"/>
            <a:ext cx="2511552" cy="195224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D810EC1-4B8F-4372-A0E4-E206086040F5}"/>
              </a:ext>
            </a:extLst>
          </p:cNvPr>
          <p:cNvSpPr/>
          <p:nvPr/>
        </p:nvSpPr>
        <p:spPr>
          <a:xfrm>
            <a:off x="1066800" y="3756392"/>
            <a:ext cx="4419600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|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|</a:t>
            </a:r>
            <a:r>
              <a:rPr lang="en-US" altLang="zh-CN" sz="1100" b="1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</a:t>
            </a:r>
            <a:r>
              <a:rPr lang="en-US" altLang="zh-CN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D</a:t>
            </a:r>
            <a:r>
              <a:rPr lang="en-US" altLang="zh-CN" sz="1100" i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e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terations on seed oil content. The seed oil content was calculated as the percentage of seed oil over seed weight, and the values are means ± SD of six biological replicates.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38827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439B67D-195B-4583-AB19-80F3EBD3B4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8540279"/>
              </p:ext>
            </p:extLst>
          </p:nvPr>
        </p:nvGraphicFramePr>
        <p:xfrm>
          <a:off x="552450" y="3201829"/>
          <a:ext cx="5753100" cy="4065270"/>
        </p:xfrm>
        <a:graphic>
          <a:graphicData uri="http://schemas.openxmlformats.org/drawingml/2006/table">
            <a:tbl>
              <a:tblPr/>
              <a:tblGrid>
                <a:gridCol w="1725930">
                  <a:extLst>
                    <a:ext uri="{9D8B030D-6E8A-4147-A177-3AD203B41FA5}">
                      <a16:colId xmlns:a16="http://schemas.microsoft.com/office/drawing/2014/main" val="2101642925"/>
                    </a:ext>
                  </a:extLst>
                </a:gridCol>
                <a:gridCol w="4027170">
                  <a:extLst>
                    <a:ext uri="{9D8B030D-6E8A-4147-A177-3AD203B41FA5}">
                      <a16:colId xmlns:a16="http://schemas.microsoft.com/office/drawing/2014/main" val="3839251464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1" dirty="0"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Supplementary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able 1 </a:t>
                      </a:r>
                      <a:r>
                        <a:rPr lang="en-US" altLang="zh-CN" sz="1200" b="1" dirty="0"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|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imers (5' to 3') used for cloning, transgenic line identification, and RT-PCR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0431297"/>
                  </a:ext>
                </a:extLst>
              </a:tr>
              <a:tr h="20955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For clon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849158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PLD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等线" panose="02010600030101010101" pitchFamily="2" charset="-122"/>
                        </a:rPr>
                        <a:t>e</a:t>
                      </a:r>
                      <a:r>
                        <a:rPr lang="el-GR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H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AGAGGGATCCATGGAGCTTGAAGAACAGAAGA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28592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GTTTCTAGAGGTGGTTAGAACAGGAGGAAA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5796259"/>
                  </a:ext>
                </a:extLst>
              </a:tr>
              <a:tr h="20955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For transgenic line identific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898732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PLD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等线" panose="02010600030101010101" pitchFamily="2" charset="-122"/>
                        </a:rPr>
                        <a:t>e</a:t>
                      </a:r>
                      <a:r>
                        <a:rPr lang="el-GR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H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CCCACTATCCTTCGCA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98890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CAGTAGGTCCGGTTAGGTTTAC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7603201"/>
                  </a:ext>
                </a:extLst>
              </a:tr>
              <a:tr h="20955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For Semi-quantitative PC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777261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act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TGACTGAGCGTGGTTATT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93433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GATCTTCATGCTGCTGGG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82431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AtPLD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等线" panose="02010600030101010101" pitchFamily="2" charset="-122"/>
                        </a:rPr>
                        <a:t>e</a:t>
                      </a:r>
                      <a:endParaRPr lang="el-GR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ATCTTGAACCGGGATGGTGCAG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211472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CCTTCCTCTGATTTCCGTTT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039561"/>
                  </a:ext>
                </a:extLst>
              </a:tr>
              <a:tr h="20955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For RT-PC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965665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act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TGACTGAGCGTGGTTATT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452094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CGTAGTCAAGGGCAATGTA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51333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GmPLD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等线" panose="02010600030101010101" pitchFamily="2" charset="-122"/>
                        </a:rPr>
                        <a:t>e</a:t>
                      </a:r>
                      <a:r>
                        <a:rPr lang="el-GR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GCTGAACAACCAAGATGAGG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32716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GAGCAAAGAGTGTGGGGA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383122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GmPLD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等线" panose="02010600030101010101" pitchFamily="2" charset="-122"/>
                        </a:rPr>
                        <a:t>e</a:t>
                      </a:r>
                      <a:r>
                        <a:rPr lang="el-GR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GAAGACTCATGATGAGGAC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094428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等线" panose="02010600030101010101" pitchFamily="2" charset="-122"/>
                        </a:rPr>
                        <a:t>TTCTCTGGCACGAACAG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24705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6568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000" dirty="0" smtClean="0">
            <a:latin typeface="Calibri" panose="020F0502020204030204" pitchFamily="34" charset="0"/>
            <a:cs typeface="Calibri" panose="020F0502020204030204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98</TotalTime>
  <Words>463</Words>
  <Application>Microsoft Office PowerPoint</Application>
  <PresentationFormat>On-screen Show (4:3)</PresentationFormat>
  <Paragraphs>4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, Shuaibing (UMSL-Student)</dc:creator>
  <cp:lastModifiedBy>xuemin wang</cp:lastModifiedBy>
  <cp:revision>171</cp:revision>
  <cp:lastPrinted>2018-10-05T16:07:32Z</cp:lastPrinted>
  <dcterms:created xsi:type="dcterms:W3CDTF">2018-08-04T01:04:58Z</dcterms:created>
  <dcterms:modified xsi:type="dcterms:W3CDTF">2022-03-04T14:26:24Z</dcterms:modified>
</cp:coreProperties>
</file>